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7" autoAdjust="0"/>
    <p:restoredTop sz="94660"/>
  </p:normalViewPr>
  <p:slideViewPr>
    <p:cSldViewPr snapToGrid="0">
      <p:cViewPr varScale="1">
        <p:scale>
          <a:sx n="80" d="100"/>
          <a:sy n="80" d="100"/>
        </p:scale>
        <p:origin x="49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A13EA-BDB8-40B5-85E5-E22A7C372A4F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6/2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066FF3-C34A-4EA6-BD99-459EFE9495CD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554275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A13EA-BDB8-40B5-85E5-E22A7C372A4F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6/2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066FF3-C34A-4EA6-BD99-459EFE9495CD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069166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A13EA-BDB8-40B5-85E5-E22A7C372A4F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6/2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066FF3-C34A-4EA6-BD99-459EFE9495CD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610336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A13EA-BDB8-40B5-85E5-E22A7C372A4F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6/2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066FF3-C34A-4EA6-BD99-459EFE9495CD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352903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A13EA-BDB8-40B5-85E5-E22A7C372A4F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6/2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066FF3-C34A-4EA6-BD99-459EFE9495CD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950443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A13EA-BDB8-40B5-85E5-E22A7C372A4F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6/2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066FF3-C34A-4EA6-BD99-459EFE9495CD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842016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A13EA-BDB8-40B5-85E5-E22A7C372A4F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6/2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066FF3-C34A-4EA6-BD99-459EFE9495CD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897093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A13EA-BDB8-40B5-85E5-E22A7C372A4F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6/2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066FF3-C34A-4EA6-BD99-459EFE9495CD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34969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A13EA-BDB8-40B5-85E5-E22A7C372A4F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6/2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066FF3-C34A-4EA6-BD99-459EFE9495CD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06350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A13EA-BDB8-40B5-85E5-E22A7C372A4F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6/2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066FF3-C34A-4EA6-BD99-459EFE9495CD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373082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A13EA-BDB8-40B5-85E5-E22A7C372A4F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6/2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066FF3-C34A-4EA6-BD99-459EFE9495CD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4965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538764"/>
            <a:fld id="{BB0A13EA-BDB8-40B5-85E5-E22A7C372A4F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538764"/>
              <a:t>2019/6/24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538764"/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538764"/>
            <a:fld id="{BE066FF3-C34A-4EA6-BD99-459EFE9495CD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 defTabSz="538764"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636236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353156" y="316672"/>
            <a:ext cx="12670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538764"/>
            <a:r>
              <a:rPr lang="en-US" altLang="ja-JP" sz="2000" b="1" dirty="0" smtClean="0">
                <a:solidFill>
                  <a:prstClr val="black"/>
                </a:solidFill>
              </a:rPr>
              <a:t>Figure S1.</a:t>
            </a:r>
          </a:p>
        </p:txBody>
      </p:sp>
      <p:cxnSp>
        <p:nvCxnSpPr>
          <p:cNvPr id="9" name="直線矢印コネクタ 8"/>
          <p:cNvCxnSpPr>
            <a:stCxn id="23" idx="1"/>
          </p:cNvCxnSpPr>
          <p:nvPr/>
        </p:nvCxnSpPr>
        <p:spPr>
          <a:xfrm flipV="1">
            <a:off x="1046394" y="1440180"/>
            <a:ext cx="4386666" cy="742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/>
          <p:cNvSpPr txBox="1"/>
          <p:nvPr/>
        </p:nvSpPr>
        <p:spPr>
          <a:xfrm>
            <a:off x="1634363" y="990671"/>
            <a:ext cx="906017" cy="4188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538764"/>
            <a:r>
              <a:rPr lang="en-US" altLang="ja-JP" sz="1061" dirty="0" smtClean="0">
                <a:solidFill>
                  <a:prstClr val="black"/>
                </a:solidFill>
              </a:rPr>
              <a:t>Immediately</a:t>
            </a:r>
            <a:r>
              <a:rPr lang="ja-JP" altLang="en-US" sz="1061" dirty="0" smtClean="0">
                <a:solidFill>
                  <a:prstClr val="black"/>
                </a:solidFill>
              </a:rPr>
              <a:t> </a:t>
            </a:r>
            <a:endParaRPr lang="en-US" altLang="ja-JP" sz="1061" dirty="0" smtClean="0">
              <a:solidFill>
                <a:prstClr val="black"/>
              </a:solidFill>
            </a:endParaRPr>
          </a:p>
          <a:p>
            <a:pPr algn="ctr" defTabSz="538764"/>
            <a:r>
              <a:rPr lang="en-US" altLang="ja-JP" sz="1061" dirty="0" smtClean="0">
                <a:solidFill>
                  <a:prstClr val="black"/>
                </a:solidFill>
              </a:rPr>
              <a:t>after</a:t>
            </a:r>
            <a:r>
              <a:rPr lang="ja-JP" altLang="en-US" sz="1061" dirty="0" smtClean="0">
                <a:solidFill>
                  <a:prstClr val="black"/>
                </a:solidFill>
              </a:rPr>
              <a:t> </a:t>
            </a:r>
            <a:r>
              <a:rPr lang="en-US" altLang="ja-JP" sz="1061" dirty="0" smtClean="0">
                <a:solidFill>
                  <a:prstClr val="black"/>
                </a:solidFill>
              </a:rPr>
              <a:t>SCI</a:t>
            </a:r>
            <a:endParaRPr lang="ja-JP" altLang="en-US" sz="1061" dirty="0">
              <a:solidFill>
                <a:prstClr val="black"/>
              </a:solidFill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173887" y="990671"/>
            <a:ext cx="651140" cy="4188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538764"/>
            <a:r>
              <a:rPr lang="en-US" altLang="ja-JP" sz="1061" dirty="0" smtClean="0">
                <a:solidFill>
                  <a:prstClr val="black"/>
                </a:solidFill>
              </a:rPr>
              <a:t>1 hour </a:t>
            </a:r>
          </a:p>
          <a:p>
            <a:pPr algn="ctr" defTabSz="538764"/>
            <a:r>
              <a:rPr lang="en-US" altLang="ja-JP" sz="1061" dirty="0" smtClean="0">
                <a:solidFill>
                  <a:prstClr val="black"/>
                </a:solidFill>
              </a:rPr>
              <a:t>after SCI</a:t>
            </a:r>
            <a:endParaRPr lang="ja-JP" altLang="en-US" sz="1061" dirty="0">
              <a:solidFill>
                <a:prstClr val="black"/>
              </a:solidFill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4458534" y="990671"/>
            <a:ext cx="681597" cy="4188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538764"/>
            <a:r>
              <a:rPr lang="en-US" altLang="ja-JP" sz="1061" dirty="0" smtClean="0">
                <a:solidFill>
                  <a:prstClr val="black"/>
                </a:solidFill>
              </a:rPr>
              <a:t>12 hours</a:t>
            </a:r>
          </a:p>
          <a:p>
            <a:pPr algn="ctr" defTabSz="538764"/>
            <a:r>
              <a:rPr lang="en-US" altLang="ja-JP" sz="1061" dirty="0" smtClean="0">
                <a:solidFill>
                  <a:prstClr val="black"/>
                </a:solidFill>
              </a:rPr>
              <a:t> after SCI</a:t>
            </a:r>
            <a:endParaRPr lang="ja-JP" altLang="en-US" sz="1061" dirty="0">
              <a:solidFill>
                <a:prstClr val="black"/>
              </a:solidFill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903727" y="1564805"/>
            <a:ext cx="606256" cy="255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538764"/>
            <a:r>
              <a:rPr lang="en-US" altLang="ja-JP" sz="1061" b="1" dirty="0" smtClean="0">
                <a:solidFill>
                  <a:prstClr val="black"/>
                </a:solidFill>
              </a:rPr>
              <a:t>Control</a:t>
            </a:r>
            <a:endParaRPr lang="ja-JP" altLang="en-US" sz="1061" b="1" dirty="0">
              <a:solidFill>
                <a:prstClr val="black"/>
              </a:solidFill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002312" y="1918613"/>
            <a:ext cx="409086" cy="255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538764"/>
            <a:r>
              <a:rPr lang="en-US" altLang="ja-JP" sz="1061" b="1" dirty="0" smtClean="0">
                <a:solidFill>
                  <a:srgbClr val="FF0000"/>
                </a:solidFill>
              </a:rPr>
              <a:t>TXA</a:t>
            </a:r>
            <a:endParaRPr lang="ja-JP" altLang="en-US" sz="1061" b="1" dirty="0">
              <a:solidFill>
                <a:srgbClr val="FF0000"/>
              </a:solidFill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888499" y="2269378"/>
            <a:ext cx="636713" cy="255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538764"/>
            <a:r>
              <a:rPr lang="en-US" altLang="ja-JP" sz="1061" b="1" dirty="0" smtClean="0">
                <a:solidFill>
                  <a:srgbClr val="0070C0"/>
                </a:solidFill>
              </a:rPr>
              <a:t>Heparin</a:t>
            </a:r>
            <a:endParaRPr lang="ja-JP" altLang="en-US" sz="1061" b="1" dirty="0">
              <a:solidFill>
                <a:srgbClr val="0070C0"/>
              </a:solidFill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1046394" y="1319812"/>
            <a:ext cx="320922" cy="255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538764"/>
            <a:r>
              <a:rPr lang="ja-JP" altLang="en-US" sz="1061" dirty="0">
                <a:solidFill>
                  <a:prstClr val="black"/>
                </a:solidFill>
              </a:rPr>
              <a:t>●</a:t>
            </a: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1016355" y="1153921"/>
            <a:ext cx="381000" cy="255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538764"/>
            <a:r>
              <a:rPr lang="en-US" altLang="ja-JP" sz="1061" dirty="0" smtClean="0">
                <a:solidFill>
                  <a:prstClr val="black"/>
                </a:solidFill>
              </a:rPr>
              <a:t>SCI</a:t>
            </a:r>
            <a:endParaRPr lang="ja-JP" altLang="en-US" sz="1061" dirty="0">
              <a:solidFill>
                <a:prstClr val="black"/>
              </a:solidFill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1926910" y="1319812"/>
            <a:ext cx="320922" cy="255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538764"/>
            <a:r>
              <a:rPr lang="ja-JP" altLang="en-US" sz="1061" dirty="0">
                <a:solidFill>
                  <a:prstClr val="black"/>
                </a:solidFill>
              </a:rPr>
              <a:t>●</a:t>
            </a: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3338996" y="1321889"/>
            <a:ext cx="320922" cy="255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538764"/>
            <a:r>
              <a:rPr lang="ja-JP" altLang="en-US" sz="1061" dirty="0">
                <a:solidFill>
                  <a:prstClr val="black"/>
                </a:solidFill>
              </a:rPr>
              <a:t>●</a:t>
            </a: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4638871" y="1319812"/>
            <a:ext cx="320922" cy="255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538764"/>
            <a:r>
              <a:rPr lang="ja-JP" altLang="en-US" sz="1061" dirty="0">
                <a:solidFill>
                  <a:prstClr val="black"/>
                </a:solidFill>
              </a:rPr>
              <a:t>●</a:t>
            </a: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1830730" y="1564805"/>
            <a:ext cx="513282" cy="255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538764"/>
            <a:r>
              <a:rPr lang="en-US" altLang="ja-JP" sz="1061" dirty="0" smtClean="0">
                <a:solidFill>
                  <a:prstClr val="black"/>
                </a:solidFill>
              </a:rPr>
              <a:t>Saline</a:t>
            </a:r>
            <a:endParaRPr lang="ja-JP" altLang="en-US" sz="1061" dirty="0">
              <a:solidFill>
                <a:prstClr val="black"/>
              </a:solidFill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242816" y="1564805"/>
            <a:ext cx="513282" cy="255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538764"/>
            <a:r>
              <a:rPr lang="en-US" altLang="ja-JP" sz="1061" dirty="0" smtClean="0">
                <a:solidFill>
                  <a:prstClr val="black"/>
                </a:solidFill>
              </a:rPr>
              <a:t>Saline</a:t>
            </a:r>
            <a:endParaRPr lang="ja-JP" altLang="en-US" sz="1061" dirty="0">
              <a:solidFill>
                <a:prstClr val="black"/>
              </a:solidFill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4542691" y="1564805"/>
            <a:ext cx="513282" cy="255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538764"/>
            <a:r>
              <a:rPr lang="en-US" altLang="ja-JP" sz="1061" dirty="0" smtClean="0">
                <a:solidFill>
                  <a:prstClr val="black"/>
                </a:solidFill>
              </a:rPr>
              <a:t>Saline</a:t>
            </a:r>
            <a:endParaRPr lang="ja-JP" altLang="en-US" sz="1061" dirty="0">
              <a:solidFill>
                <a:prstClr val="black"/>
              </a:solidFill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3242816" y="1918613"/>
            <a:ext cx="513282" cy="255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538764"/>
            <a:r>
              <a:rPr lang="en-US" altLang="ja-JP" sz="1061" dirty="0" smtClean="0">
                <a:solidFill>
                  <a:prstClr val="black"/>
                </a:solidFill>
              </a:rPr>
              <a:t>Saline</a:t>
            </a:r>
            <a:endParaRPr lang="ja-JP" altLang="en-US" sz="1061" dirty="0">
              <a:solidFill>
                <a:prstClr val="black"/>
              </a:solidFill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4542691" y="1918613"/>
            <a:ext cx="513282" cy="255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538764"/>
            <a:r>
              <a:rPr lang="en-US" altLang="ja-JP" sz="1061" dirty="0" smtClean="0">
                <a:solidFill>
                  <a:prstClr val="black"/>
                </a:solidFill>
              </a:rPr>
              <a:t>Saline</a:t>
            </a:r>
            <a:endParaRPr lang="ja-JP" altLang="en-US" sz="1061" dirty="0">
              <a:solidFill>
                <a:prstClr val="black"/>
              </a:solidFill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1830730" y="2269378"/>
            <a:ext cx="513282" cy="255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538764"/>
            <a:r>
              <a:rPr lang="en-US" altLang="ja-JP" sz="1061" dirty="0" smtClean="0">
                <a:solidFill>
                  <a:prstClr val="black"/>
                </a:solidFill>
              </a:rPr>
              <a:t>Saline</a:t>
            </a:r>
            <a:endParaRPr lang="ja-JP" altLang="en-US" sz="1061" dirty="0">
              <a:solidFill>
                <a:prstClr val="black"/>
              </a:solidFill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1887637" y="1918613"/>
            <a:ext cx="399468" cy="255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538764"/>
            <a:r>
              <a:rPr lang="en-US" altLang="ja-JP" sz="1061" dirty="0" smtClean="0">
                <a:solidFill>
                  <a:prstClr val="black"/>
                </a:solidFill>
              </a:rPr>
              <a:t>TXA</a:t>
            </a:r>
            <a:endParaRPr lang="ja-JP" altLang="en-US" sz="1061" dirty="0">
              <a:solidFill>
                <a:prstClr val="black"/>
              </a:solidFill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3186711" y="2269378"/>
            <a:ext cx="625492" cy="255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538764"/>
            <a:r>
              <a:rPr lang="en-US" altLang="ja-JP" sz="1061" dirty="0" smtClean="0">
                <a:solidFill>
                  <a:prstClr val="black"/>
                </a:solidFill>
              </a:rPr>
              <a:t>Heparin</a:t>
            </a:r>
            <a:endParaRPr lang="ja-JP" altLang="en-US" sz="1061" dirty="0">
              <a:solidFill>
                <a:prstClr val="black"/>
              </a:solidFill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4486586" y="2269378"/>
            <a:ext cx="625492" cy="255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538764"/>
            <a:r>
              <a:rPr lang="en-US" altLang="ja-JP" sz="1061" dirty="0" smtClean="0">
                <a:solidFill>
                  <a:prstClr val="black"/>
                </a:solidFill>
              </a:rPr>
              <a:t>Heparin</a:t>
            </a:r>
            <a:endParaRPr lang="ja-JP" altLang="en-US" sz="1061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62499649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2</Words>
  <Application>Microsoft Office PowerPoint</Application>
  <PresentationFormat>A4 210 x 297 mm</PresentationFormat>
  <Paragraphs>2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1_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cool__000</dc:creator>
  <cp:lastModifiedBy>吉崎 真吾</cp:lastModifiedBy>
  <cp:revision>3</cp:revision>
  <dcterms:created xsi:type="dcterms:W3CDTF">2019-06-21T02:29:41Z</dcterms:created>
  <dcterms:modified xsi:type="dcterms:W3CDTF">2019-06-24T09:06:32Z</dcterms:modified>
</cp:coreProperties>
</file>